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28" r:id="rId2"/>
    <p:sldId id="331" r:id="rId3"/>
    <p:sldId id="338" r:id="rId4"/>
    <p:sldId id="281" r:id="rId5"/>
    <p:sldId id="286" r:id="rId6"/>
    <p:sldId id="289" r:id="rId7"/>
    <p:sldId id="309" r:id="rId8"/>
  </p:sldIdLst>
  <p:sldSz cx="12192000" cy="6858000"/>
  <p:notesSz cx="6797675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4C376A1-B353-41DD-98BB-A77EB45BC947}" v="2" dt="2025-07-02T09:33:27.4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2437" autoAdjust="0"/>
  </p:normalViewPr>
  <p:slideViewPr>
    <p:cSldViewPr snapToGrid="0" showGuides="1">
      <p:cViewPr varScale="1">
        <p:scale>
          <a:sx n="58" d="100"/>
          <a:sy n="58" d="100"/>
        </p:scale>
        <p:origin x="988" y="52"/>
      </p:cViewPr>
      <p:guideLst>
        <p:guide orient="horz" pos="213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1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21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023122F-41A8-4C4F-8E3C-022253437502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0688" y="1241425"/>
            <a:ext cx="59563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8722"/>
            <a:ext cx="5438140" cy="3909864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5659" cy="498214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1600"/>
            <a:ext cx="2945659" cy="498214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4DA276E-CC36-488D-BB0C-03F46CD6E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5866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A0E14B-5AF5-396E-2903-594926BE8B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78C069-085C-7169-6D7F-26491E9072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B80529-69F6-5254-3126-A0A7D9C1C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3D78D8-E7DE-4A07-F4DE-AC4C0A4E9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9AA496-63E0-1068-AE08-B8C522ABE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856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8064AE-3FD8-906E-D009-0E5006D2F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A89DDC-8217-52DA-0C0C-22D41F623F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307A42-00BE-70C4-28C3-20AD0CD5D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7692EB-DC67-F08B-009C-42F4069D0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1F1A6B-347F-78E9-4D09-33F880C76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078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58B3EC3-AF54-2AA5-7E11-2A7D510351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21D9CB-5CF5-15F0-3335-C0D68B3D5C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A3C223-800D-255C-8F87-8487C547B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8CE07C-D6BB-4397-C967-E69956FAC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D37BB-C162-4F97-4627-7EBA291482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611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FA94D0-D69F-57DF-0452-CD7530EB70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B39B90-BE56-20CE-E4BC-15CB127891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7093D9-42F4-69D0-BF6E-6491998AA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39FD01-59C6-1943-4D09-4CF6C20D10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96AC9E-4EB9-CC65-2815-A514BDDF1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448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B5778B-C088-8730-5497-104C709DC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FB51EE-EE7E-AF45-DBD1-E1685FDB2D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0419AF-C878-081B-E1C4-80A8AE65B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5B74F1-7269-EBBE-8F67-90246E1EF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7A65C9-A3A7-DA2A-1F2A-03D8E327B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073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E4CBC8-19A4-2528-920A-02A1A5C08B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9752EC-F95D-EEBC-2B45-3FA5A1BC90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9D61CA-ACDE-9DB7-6BB3-6984E5C2BE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BA251C-7977-A6C9-49AE-87AB4E293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010A28-99D2-57E3-D24C-0EB91654E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51EA71-BDF0-3E2C-3836-05BE8CA41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998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0E0C7-C494-61DA-380D-8A14200F36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5A6068-56BC-A0A4-55AF-CC46319988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3A6E56-14B7-3664-5B33-35269B4EFC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DDC25C3-B8F2-D1F0-BD21-D48739FE37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A292B8B-FE49-114C-460C-1E7CD17A4A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75BBB5-82D7-9A71-B62C-A9AB4E1E1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710F58-9D92-FE8F-5E9C-F6637E130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4B7C4EA-B5F8-1D3A-21BF-398A74C50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57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518FD0-5EFF-0BBC-50BB-237BD9B6EE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8468C19-D2AF-A27B-0BB7-0DCD69435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E83FDB-ACBE-DDF3-9A75-E310C55A0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3CC950-46A9-4BF6-0BA4-87A157BDC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0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3E935AD-EB67-563A-A9E2-AA4293669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8D8A98-D221-E8EB-8128-4555F0CA2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D072AC-E326-EEBC-8455-0B8438041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452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FFE13-DB0A-CD44-06C9-EAD9118B5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A4B1AB-B9FD-6513-F3A2-F4A3070A94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69D21A-C1F2-403D-7F89-3E9C9A6B12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AEC5E4-03C2-5D55-CD43-E6C8A42C1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6A4CED-5E2B-D74B-E264-1926AA61F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B1639B-8BEA-AA60-0AE5-90C1F206DD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614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37C672-9572-EC31-E418-62085C737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801359-4ACD-2852-46B7-E5D7738F0B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00F517-D779-F429-A596-CD6DF99B8E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EC1D1A-2209-05A3-9F39-2FB9DFBB4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1482D8-062C-3DCB-D125-13B3F22D4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B89C0A-2890-F142-5F20-5533E6F67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3006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397D536-E57C-175C-8F0B-A7423C184B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C1C903-56AA-2DFE-B96B-E4EEBA6D4A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AC23AF-B30A-A899-C93B-36E07B00E6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75D489A-3ECB-4D34-BF44-73CC66292F7C}" type="datetimeFigureOut">
              <a:rPr lang="en-US" smtClean="0"/>
              <a:t>8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032585-CE04-50C9-9714-DC2447CEE8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BD70F6-4615-A215-77C3-1C00C775D5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20DC52-DD88-48E1-A501-AE9B4A72A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965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984C4AFE-841D-2E35-6327-8FBEDEBAA97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74913" y="227013"/>
          <a:ext cx="7351712" cy="3068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7780012" imgH="3246545" progId="Prism10.Document">
                  <p:embed/>
                </p:oleObj>
              </mc:Choice>
              <mc:Fallback>
                <p:oleObj name="Prism 10" r:id="rId2" imgW="7780012" imgH="3246545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984C4AFE-841D-2E35-6327-8FBEDEBAA9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74913" y="227013"/>
                        <a:ext cx="7351712" cy="3068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DF167E0D-B0D3-65B0-2440-0E755EE7923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74913" y="3369946"/>
          <a:ext cx="7427913" cy="3106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7761645" imgH="3246545" progId="Prism10.Document">
                  <p:embed/>
                </p:oleObj>
              </mc:Choice>
              <mc:Fallback>
                <p:oleObj name="Prism 10" r:id="rId4" imgW="7761645" imgH="3246545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DF167E0D-B0D3-65B0-2440-0E755EE792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74913" y="3369946"/>
                        <a:ext cx="7427913" cy="3106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59F1FEC-5224-37BB-77D8-F034CE5E6877}"/>
              </a:ext>
            </a:extLst>
          </p:cNvPr>
          <p:cNvSpPr txBox="1"/>
          <p:nvPr/>
        </p:nvSpPr>
        <p:spPr>
          <a:xfrm>
            <a:off x="121185" y="209771"/>
            <a:ext cx="2278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Supplementary Fig. 1</a:t>
            </a:r>
          </a:p>
        </p:txBody>
      </p:sp>
    </p:spTree>
    <p:extLst>
      <p:ext uri="{BB962C8B-B14F-4D97-AF65-F5344CB8AC3E}">
        <p14:creationId xmlns:p14="http://schemas.microsoft.com/office/powerpoint/2010/main" val="4075906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D2B51E4-4C4E-B75A-87C2-D8B0D9DEA6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5468591"/>
              </p:ext>
            </p:extLst>
          </p:nvPr>
        </p:nvGraphicFramePr>
        <p:xfrm>
          <a:off x="2907506" y="209771"/>
          <a:ext cx="6376988" cy="3019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6563473" imgH="3106487" progId="Prism10.Document">
                  <p:embed/>
                </p:oleObj>
              </mc:Choice>
              <mc:Fallback>
                <p:oleObj name="Prism 10" r:id="rId2" imgW="6563473" imgH="3106487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D2B51E4-4C4E-B75A-87C2-D8B0D9DEA6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07506" y="209771"/>
                        <a:ext cx="6376988" cy="3019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D08F3F5-767F-E9A8-9FC4-C65457C7FE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3256118"/>
              </p:ext>
            </p:extLst>
          </p:nvPr>
        </p:nvGraphicFramePr>
        <p:xfrm>
          <a:off x="2844006" y="3257454"/>
          <a:ext cx="6503988" cy="3027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6692762" imgH="3115488" progId="Prism10.Document">
                  <p:embed/>
                </p:oleObj>
              </mc:Choice>
              <mc:Fallback>
                <p:oleObj name="Prism 10" r:id="rId4" imgW="6692762" imgH="3115488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D08F3F5-767F-E9A8-9FC4-C65457C7FE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44006" y="3257454"/>
                        <a:ext cx="6503988" cy="3027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4793A37-21B0-EFBA-860F-6EF85A1F3DED}"/>
              </a:ext>
            </a:extLst>
          </p:cNvPr>
          <p:cNvSpPr txBox="1"/>
          <p:nvPr/>
        </p:nvSpPr>
        <p:spPr>
          <a:xfrm>
            <a:off x="121185" y="209771"/>
            <a:ext cx="2278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Supplementary Fig. 2</a:t>
            </a:r>
          </a:p>
        </p:txBody>
      </p:sp>
    </p:spTree>
    <p:extLst>
      <p:ext uri="{BB962C8B-B14F-4D97-AF65-F5344CB8AC3E}">
        <p14:creationId xmlns:p14="http://schemas.microsoft.com/office/powerpoint/2010/main" val="23348980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E81C216-904E-26C7-82C6-F598545C06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62035"/>
            <a:ext cx="12192000" cy="253392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EB987F0-8833-3A44-FBEA-BF2460978494}"/>
              </a:ext>
            </a:extLst>
          </p:cNvPr>
          <p:cNvSpPr txBox="1"/>
          <p:nvPr/>
        </p:nvSpPr>
        <p:spPr>
          <a:xfrm>
            <a:off x="231354" y="209771"/>
            <a:ext cx="2278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Supplementary Fig. 3</a:t>
            </a:r>
          </a:p>
        </p:txBody>
      </p:sp>
    </p:spTree>
    <p:extLst>
      <p:ext uri="{BB962C8B-B14F-4D97-AF65-F5344CB8AC3E}">
        <p14:creationId xmlns:p14="http://schemas.microsoft.com/office/powerpoint/2010/main" val="21596731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342FF37-99DF-C7BA-1CB0-74EBB14B67B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4999" y="859429"/>
          <a:ext cx="7470775" cy="2954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7470295" imgH="2953827" progId="Prism10.Document">
                  <p:embed/>
                </p:oleObj>
              </mc:Choice>
              <mc:Fallback>
                <p:oleObj name="Prism 10" r:id="rId2" imgW="7470295" imgH="2953827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342FF37-99DF-C7BA-1CB0-74EBB14B67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4999" y="859429"/>
                        <a:ext cx="7470775" cy="2954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A4A7A27B-D649-449E-751D-C0F1D01670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24765" y="0"/>
            <a:ext cx="367032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003AFEE-3A78-48A0-7EBA-DB127DDB93D5}"/>
              </a:ext>
            </a:extLst>
          </p:cNvPr>
          <p:cNvSpPr txBox="1"/>
          <p:nvPr/>
        </p:nvSpPr>
        <p:spPr>
          <a:xfrm>
            <a:off x="8390249" y="122378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SG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0242D75-D249-8171-6239-C38DA5D8F358}"/>
              </a:ext>
            </a:extLst>
          </p:cNvPr>
          <p:cNvSpPr txBox="1"/>
          <p:nvPr/>
        </p:nvSpPr>
        <p:spPr>
          <a:xfrm>
            <a:off x="1648375" y="859429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SG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1AAB7C1-E2B2-0E43-9E3D-042FC8A300C9}"/>
              </a:ext>
            </a:extLst>
          </p:cNvPr>
          <p:cNvSpPr txBox="1"/>
          <p:nvPr/>
        </p:nvSpPr>
        <p:spPr>
          <a:xfrm>
            <a:off x="231354" y="209771"/>
            <a:ext cx="2278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Supplementary Fig. 4</a:t>
            </a:r>
          </a:p>
        </p:txBody>
      </p:sp>
    </p:spTree>
    <p:extLst>
      <p:ext uri="{BB962C8B-B14F-4D97-AF65-F5344CB8AC3E}">
        <p14:creationId xmlns:p14="http://schemas.microsoft.com/office/powerpoint/2010/main" val="23978000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2304D5D-776D-BE94-13B1-EE8C2FD8A1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626" y="0"/>
            <a:ext cx="6547676" cy="658368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5259F1B-42CF-6620-8151-23BA2C721BB0}"/>
              </a:ext>
            </a:extLst>
          </p:cNvPr>
          <p:cNvSpPr txBox="1"/>
          <p:nvPr/>
        </p:nvSpPr>
        <p:spPr>
          <a:xfrm>
            <a:off x="4388546" y="6116213"/>
            <a:ext cx="14163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0hr_CS10</a:t>
            </a:r>
            <a:endParaRPr lang="en-SG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BE1D570-75F0-DDD6-6806-EC91818661BE}"/>
              </a:ext>
            </a:extLst>
          </p:cNvPr>
          <p:cNvSpPr txBox="1"/>
          <p:nvPr/>
        </p:nvSpPr>
        <p:spPr>
          <a:xfrm>
            <a:off x="5520010" y="6129512"/>
            <a:ext cx="14163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4hr_CS10</a:t>
            </a:r>
            <a:endParaRPr lang="en-SG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6470FED-079E-0143-1920-91E04DAF1513}"/>
              </a:ext>
            </a:extLst>
          </p:cNvPr>
          <p:cNvSpPr txBox="1"/>
          <p:nvPr/>
        </p:nvSpPr>
        <p:spPr>
          <a:xfrm>
            <a:off x="6936342" y="6116072"/>
            <a:ext cx="9970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0hr_XT-Thrive</a:t>
            </a:r>
            <a:endParaRPr lang="en-SG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A38820D-C18E-72B2-2798-77BAEBF37BF7}"/>
              </a:ext>
            </a:extLst>
          </p:cNvPr>
          <p:cNvSpPr txBox="1"/>
          <p:nvPr/>
        </p:nvSpPr>
        <p:spPr>
          <a:xfrm>
            <a:off x="7933437" y="6116072"/>
            <a:ext cx="11314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4hr_XT-Thrive</a:t>
            </a:r>
            <a:endParaRPr lang="en-SG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6723C40-9AFB-5B39-7A58-F9F7AA678CFC}"/>
              </a:ext>
            </a:extLst>
          </p:cNvPr>
          <p:cNvSpPr txBox="1"/>
          <p:nvPr/>
        </p:nvSpPr>
        <p:spPr>
          <a:xfrm>
            <a:off x="231354" y="209771"/>
            <a:ext cx="2278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Supplementary Fig. 5</a:t>
            </a:r>
          </a:p>
        </p:txBody>
      </p:sp>
    </p:spTree>
    <p:extLst>
      <p:ext uri="{BB962C8B-B14F-4D97-AF65-F5344CB8AC3E}">
        <p14:creationId xmlns:p14="http://schemas.microsoft.com/office/powerpoint/2010/main" val="35923645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32C6A5B-60E8-448F-B785-2F844B0EDD48}"/>
              </a:ext>
            </a:extLst>
          </p:cNvPr>
          <p:cNvSpPr txBox="1"/>
          <p:nvPr/>
        </p:nvSpPr>
        <p:spPr>
          <a:xfrm>
            <a:off x="3384207" y="165492"/>
            <a:ext cx="226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0hr_CS10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8F495C7-5259-4BED-9C10-4C4D20D456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9400" y="536276"/>
            <a:ext cx="3592417" cy="27432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35B2530-17B5-4BBC-A5BB-8862DA6643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6294" y="482028"/>
            <a:ext cx="3501979" cy="27432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E37B6A9-41C0-B50C-F827-348B2156677E}"/>
              </a:ext>
            </a:extLst>
          </p:cNvPr>
          <p:cNvSpPr txBox="1"/>
          <p:nvPr/>
        </p:nvSpPr>
        <p:spPr>
          <a:xfrm>
            <a:off x="7156694" y="165492"/>
            <a:ext cx="226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4hr_CS10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400D77C-D627-B168-3D4C-1D9105C437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19400" y="3949308"/>
            <a:ext cx="3427974" cy="27432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12FF78D-3B41-416A-B8D5-16371E4D55A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35008" y="3949308"/>
            <a:ext cx="3333265" cy="27432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D52E84A-2FE7-0382-19A1-DC9269CE1256}"/>
              </a:ext>
            </a:extLst>
          </p:cNvPr>
          <p:cNvSpPr txBox="1"/>
          <p:nvPr/>
        </p:nvSpPr>
        <p:spPr>
          <a:xfrm>
            <a:off x="3384207" y="3541764"/>
            <a:ext cx="226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0hr_XT-Thriv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FED4EB-0E3F-895A-5E56-1C4C37A5BEF9}"/>
              </a:ext>
            </a:extLst>
          </p:cNvPr>
          <p:cNvSpPr txBox="1"/>
          <p:nvPr/>
        </p:nvSpPr>
        <p:spPr>
          <a:xfrm>
            <a:off x="7156694" y="3541764"/>
            <a:ext cx="226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4hr_XT-Thriv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600FA9F-A6B7-C0D4-BC08-DA2E862229A0}"/>
              </a:ext>
            </a:extLst>
          </p:cNvPr>
          <p:cNvSpPr txBox="1"/>
          <p:nvPr/>
        </p:nvSpPr>
        <p:spPr>
          <a:xfrm>
            <a:off x="174166" y="165492"/>
            <a:ext cx="2278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Supplementary Fig. 6</a:t>
            </a:r>
          </a:p>
        </p:txBody>
      </p:sp>
    </p:spTree>
    <p:extLst>
      <p:ext uri="{BB962C8B-B14F-4D97-AF65-F5344CB8AC3E}">
        <p14:creationId xmlns:p14="http://schemas.microsoft.com/office/powerpoint/2010/main" val="20059547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D4136936-CFAD-5DF2-DA05-86E25398D8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5965" y="457200"/>
            <a:ext cx="7995768" cy="5943600"/>
          </a:xfrm>
          <a:prstGeom prst="rect">
            <a:avLst/>
          </a:prstGeom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id="{16CA4495-1F05-39DC-D7F1-2A3912CBB007}"/>
              </a:ext>
            </a:extLst>
          </p:cNvPr>
          <p:cNvGrpSpPr/>
          <p:nvPr/>
        </p:nvGrpSpPr>
        <p:grpSpPr>
          <a:xfrm>
            <a:off x="4350853" y="5439122"/>
            <a:ext cx="2038641" cy="369332"/>
            <a:chOff x="9318576" y="2965167"/>
            <a:chExt cx="2038641" cy="369332"/>
          </a:xfrm>
        </p:grpSpPr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76B30923-8BEB-4CB5-B8AC-E8DA0F7EAE87}"/>
                </a:ext>
              </a:extLst>
            </p:cNvPr>
            <p:cNvSpPr/>
            <p:nvPr/>
          </p:nvSpPr>
          <p:spPr>
            <a:xfrm>
              <a:off x="9318576" y="3017974"/>
              <a:ext cx="253219" cy="253219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2B06C72-AC15-4ADE-BCEF-762AA0DA7ADD}"/>
                </a:ext>
              </a:extLst>
            </p:cNvPr>
            <p:cNvSpPr txBox="1"/>
            <p:nvPr/>
          </p:nvSpPr>
          <p:spPr>
            <a:xfrm>
              <a:off x="9626890" y="2965167"/>
              <a:ext cx="17303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Injection sites</a:t>
              </a:r>
              <a:endParaRPr lang="en-SG" dirty="0"/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303A7C62-8411-4F85-AEC5-8F724104389A}"/>
              </a:ext>
            </a:extLst>
          </p:cNvPr>
          <p:cNvSpPr txBox="1"/>
          <p:nvPr/>
        </p:nvSpPr>
        <p:spPr>
          <a:xfrm>
            <a:off x="2818193" y="707753"/>
            <a:ext cx="1330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0hr-CS10</a:t>
            </a:r>
            <a:endParaRPr lang="en-SG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6D00ECF-ED3E-4A8F-89B9-85A3384E7291}"/>
              </a:ext>
            </a:extLst>
          </p:cNvPr>
          <p:cNvSpPr txBox="1"/>
          <p:nvPr/>
        </p:nvSpPr>
        <p:spPr>
          <a:xfrm>
            <a:off x="4951315" y="698096"/>
            <a:ext cx="1209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hr-CS10</a:t>
            </a:r>
            <a:endParaRPr lang="en-SG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5EA5D33-5632-43CD-898F-AD9A8D85F85F}"/>
              </a:ext>
            </a:extLst>
          </p:cNvPr>
          <p:cNvSpPr txBox="1"/>
          <p:nvPr/>
        </p:nvSpPr>
        <p:spPr>
          <a:xfrm>
            <a:off x="6938575" y="698096"/>
            <a:ext cx="15271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hr-XT-Thrive</a:t>
            </a:r>
            <a:endParaRPr lang="en-SG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795D8F-65EF-4936-B035-FE4E3D1C7999}"/>
              </a:ext>
            </a:extLst>
          </p:cNvPr>
          <p:cNvSpPr txBox="1"/>
          <p:nvPr/>
        </p:nvSpPr>
        <p:spPr>
          <a:xfrm>
            <a:off x="8483508" y="560989"/>
            <a:ext cx="1603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hr-XT-Thrive</a:t>
            </a:r>
            <a:endParaRPr lang="en-SG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3F6F4D8-2D9E-013D-D760-B69BD115DCB9}"/>
              </a:ext>
            </a:extLst>
          </p:cNvPr>
          <p:cNvSpPr txBox="1"/>
          <p:nvPr/>
        </p:nvSpPr>
        <p:spPr>
          <a:xfrm>
            <a:off x="231354" y="209771"/>
            <a:ext cx="2278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Supplementary Fig. 7</a:t>
            </a:r>
          </a:p>
        </p:txBody>
      </p:sp>
    </p:spTree>
    <p:extLst>
      <p:ext uri="{BB962C8B-B14F-4D97-AF65-F5344CB8AC3E}">
        <p14:creationId xmlns:p14="http://schemas.microsoft.com/office/powerpoint/2010/main" val="2360525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6</TotalTime>
  <Words>64</Words>
  <Application>Microsoft Office PowerPoint</Application>
  <PresentationFormat>Widescreen</PresentationFormat>
  <Paragraphs>22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ptos</vt:lpstr>
      <vt:lpstr>Aptos Display</vt:lpstr>
      <vt:lpstr>Arial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an Lam</dc:creator>
  <cp:lastModifiedBy>Alan Lam</cp:lastModifiedBy>
  <cp:revision>27</cp:revision>
  <cp:lastPrinted>2024-10-03T09:36:57Z</cp:lastPrinted>
  <dcterms:created xsi:type="dcterms:W3CDTF">2024-09-03T10:27:28Z</dcterms:created>
  <dcterms:modified xsi:type="dcterms:W3CDTF">2025-08-29T06:33:37Z</dcterms:modified>
</cp:coreProperties>
</file>